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  <p:sldId id="267" r:id="rId4"/>
    <p:sldId id="268" r:id="rId5"/>
    <p:sldId id="269" r:id="rId6"/>
    <p:sldId id="270" r:id="rId7"/>
    <p:sldId id="271" r:id="rId8"/>
    <p:sldId id="272" r:id="rId9"/>
    <p:sldId id="273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18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E2E86-03F9-428D-8926-D7F62B0095D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7EB7-3D7D-47E3-820E-A4FB338B5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679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E2E86-03F9-428D-8926-D7F62B0095D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7EB7-3D7D-47E3-820E-A4FB338B5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474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E2E86-03F9-428D-8926-D7F62B0095D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7EB7-3D7D-47E3-820E-A4FB338B5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485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E2E86-03F9-428D-8926-D7F62B0095D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7EB7-3D7D-47E3-820E-A4FB338B5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210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E2E86-03F9-428D-8926-D7F62B0095D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7EB7-3D7D-47E3-820E-A4FB338B5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739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E2E86-03F9-428D-8926-D7F62B0095D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7EB7-3D7D-47E3-820E-A4FB338B5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276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E2E86-03F9-428D-8926-D7F62B0095D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7EB7-3D7D-47E3-820E-A4FB338B5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413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E2E86-03F9-428D-8926-D7F62B0095D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7EB7-3D7D-47E3-820E-A4FB338B5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828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E2E86-03F9-428D-8926-D7F62B0095D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7EB7-3D7D-47E3-820E-A4FB338B5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62008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E2E86-03F9-428D-8926-D7F62B0095D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7EB7-3D7D-47E3-820E-A4FB338B5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171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1E2E86-03F9-428D-8926-D7F62B0095D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7EB7-3D7D-47E3-820E-A4FB338B5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711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1E2E86-03F9-428D-8926-D7F62B0095DE}" type="datetimeFigureOut">
              <a:rPr lang="en-US" smtClean="0"/>
              <a:t>3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4F7EB7-3D7D-47E3-820E-A4FB338B5A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023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8425" y="2147888"/>
            <a:ext cx="3867150" cy="2562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886200" y="5334000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/>
              <a:t>S1 </a:t>
            </a:r>
          </a:p>
        </p:txBody>
      </p:sp>
    </p:spTree>
    <p:extLst>
      <p:ext uri="{BB962C8B-B14F-4D97-AF65-F5344CB8AC3E}">
        <p14:creationId xmlns:p14="http://schemas.microsoft.com/office/powerpoint/2010/main" val="21269143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8425" y="2147888"/>
            <a:ext cx="3867150" cy="2562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886200" y="5334000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 smtClean="0"/>
              <a:t>S2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27065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8425" y="2147888"/>
            <a:ext cx="3867150" cy="2562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886200" y="5334000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 smtClean="0"/>
              <a:t>S3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54384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4138" y="2100263"/>
            <a:ext cx="3895725" cy="265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886200" y="5334000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 smtClean="0"/>
              <a:t>S4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79018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52663" y="2147888"/>
            <a:ext cx="4638675" cy="2562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886200" y="5334000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 smtClean="0"/>
              <a:t>S5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82064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7450" y="2286000"/>
            <a:ext cx="3867150" cy="2562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886200" y="5334000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 smtClean="0"/>
              <a:t>S6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363323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5088" y="2147888"/>
            <a:ext cx="3933825" cy="2562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886200" y="5334000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 smtClean="0"/>
              <a:t>S7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050808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2286000"/>
            <a:ext cx="4638675" cy="2562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886200" y="5334000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 smtClean="0"/>
              <a:t>S8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52408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3600" y="1981200"/>
            <a:ext cx="4638675" cy="2562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886200" y="5334000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</a:t>
            </a:r>
            <a:r>
              <a:rPr lang="en-US" dirty="0" smtClean="0"/>
              <a:t>S9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30381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7</TotalTime>
  <Words>18</Words>
  <Application>Microsoft Office PowerPoint</Application>
  <PresentationFormat>On-screen Show (4:3)</PresentationFormat>
  <Paragraphs>9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dhar Arumugam</dc:creator>
  <cp:lastModifiedBy>Sridhar Arumugam</cp:lastModifiedBy>
  <cp:revision>43</cp:revision>
  <dcterms:created xsi:type="dcterms:W3CDTF">2015-09-21T21:01:37Z</dcterms:created>
  <dcterms:modified xsi:type="dcterms:W3CDTF">2016-03-15T20:58:48Z</dcterms:modified>
</cp:coreProperties>
</file>